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8799B23B-EC83-4686-B30A-512413B5E67A}" styleName="淡色スタイル 3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1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44395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206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940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8174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9309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31495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038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124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1702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4176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0722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5E9BFD-2F64-4C5A-8A77-EB41179CF1C1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9BA5A-0D0D-4A3C-BB04-50B8404BC4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627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A48A7BC4-892B-4688-9BFE-0549AD114D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9939114"/>
              </p:ext>
            </p:extLst>
          </p:nvPr>
        </p:nvGraphicFramePr>
        <p:xfrm>
          <a:off x="1187430" y="1798642"/>
          <a:ext cx="4483140" cy="49349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25540">
                  <a:extLst>
                    <a:ext uri="{9D8B030D-6E8A-4147-A177-3AD203B41FA5}">
                      <a16:colId xmlns:a16="http://schemas.microsoft.com/office/drawing/2014/main" val="836094787"/>
                    </a:ext>
                  </a:extLst>
                </a:gridCol>
                <a:gridCol w="760021">
                  <a:extLst>
                    <a:ext uri="{9D8B030D-6E8A-4147-A177-3AD203B41FA5}">
                      <a16:colId xmlns:a16="http://schemas.microsoft.com/office/drawing/2014/main" val="2787016927"/>
                    </a:ext>
                  </a:extLst>
                </a:gridCol>
                <a:gridCol w="2897579">
                  <a:extLst>
                    <a:ext uri="{9D8B030D-6E8A-4147-A177-3AD203B41FA5}">
                      <a16:colId xmlns:a16="http://schemas.microsoft.com/office/drawing/2014/main" val="3445858552"/>
                    </a:ext>
                  </a:extLst>
                </a:gridCol>
              </a:tblGrid>
              <a:tr h="450826">
                <a:tc>
                  <a:txBody>
                    <a:bodyPr/>
                    <a:lstStyle/>
                    <a:p>
                      <a:r>
                        <a:rPr kumimoji="1" lang="en-US" altLang="ja-JP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kumimoji="1" lang="ja-JP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kumimoji="1" lang="ja-JP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pairs</a:t>
                      </a:r>
                      <a:endParaRPr kumimoji="1" lang="ja-JP" altLang="en-US" sz="11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7429815"/>
                  </a:ext>
                </a:extLst>
              </a:tr>
              <a:tr h="366691">
                <a:tc>
                  <a:txBody>
                    <a:bodyPr/>
                    <a:lstStyle/>
                    <a:p>
                      <a:r>
                        <a:rPr kumimoji="1" lang="en-US" altLang="ja-JP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9</a:t>
                      </a:r>
                      <a:endParaRPr kumimoji="1" lang="ja-JP" alt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orward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everse</a:t>
                      </a:r>
                      <a:endParaRPr kumimoji="1" lang="ja-JP" altLang="en-US" sz="11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 CTG TTG CCT GTA GAT GG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 CCG GAC GGT ATT GTA GA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09568157"/>
                  </a:ext>
                </a:extLst>
              </a:tr>
              <a:tr h="450826">
                <a:tc>
                  <a:txBody>
                    <a:bodyPr/>
                    <a:lstStyle/>
                    <a:p>
                      <a:r>
                        <a:rPr kumimoji="1" lang="en-US" altLang="ja-JP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hr</a:t>
                      </a:r>
                      <a:endParaRPr kumimoji="1" lang="ja-JP" alt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 CAC TGT GTC CAA GGC CA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C GGA AGT TCT TGG TGA AAA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52505"/>
                  </a:ext>
                </a:extLst>
              </a:tr>
              <a:tr h="450826">
                <a:tc>
                  <a:txBody>
                    <a:bodyPr/>
                    <a:lstStyle/>
                    <a:p>
                      <a:r>
                        <a:rPr kumimoji="1" lang="en-US" altLang="ja-JP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h</a:t>
                      </a:r>
                      <a:endParaRPr kumimoji="1" lang="ja-JP" alt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C CCT AAC CCT TCA ACC AA</a:t>
                      </a:r>
                    </a:p>
                    <a:p>
                      <a:r>
                        <a:rPr kumimoji="1" lang="en-US" altLang="ja-JP" sz="11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T GAA ACA GCG GGA GTC AG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0683202"/>
                  </a:ext>
                </a:extLst>
              </a:tr>
              <a:tr h="450826">
                <a:tc>
                  <a:txBody>
                    <a:bodyPr/>
                    <a:lstStyle/>
                    <a:p>
                      <a:r>
                        <a:rPr kumimoji="1" lang="en-US" altLang="ja-JP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19a1</a:t>
                      </a:r>
                      <a:endParaRPr kumimoji="1" lang="ja-JP" alt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 TCA GCA GAG AAA CTG GAA GA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 ACA GAG TGA CGG ACA TGG T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32693519"/>
                  </a:ext>
                </a:extLst>
              </a:tr>
              <a:tr h="450826">
                <a:tc>
                  <a:txBody>
                    <a:bodyPr/>
                    <a:lstStyle/>
                    <a:p>
                      <a:r>
                        <a:rPr kumimoji="1" lang="en-US" altLang="ja-JP" sz="11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hcgr</a:t>
                      </a:r>
                      <a:endParaRPr kumimoji="1" lang="ja-JP" alt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A TTC AAG AGA TGC ACT GTG CAG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G CAG AGT GTC AAT GGG AAA TGA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01853652"/>
                  </a:ext>
                </a:extLst>
              </a:tr>
              <a:tr h="450826">
                <a:tc>
                  <a:txBody>
                    <a:bodyPr/>
                    <a:lstStyle/>
                    <a:p>
                      <a:r>
                        <a:rPr kumimoji="1" lang="en-US" altLang="ja-JP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r</a:t>
                      </a:r>
                      <a:endParaRPr kumimoji="1" lang="ja-JP" alt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sv-SE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 TAG AGT TCG CCA GCC AC</a:t>
                      </a:r>
                    </a:p>
                    <a:p>
                      <a:r>
                        <a:rPr kumimoji="1" lang="en-US" altLang="ja-JP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G AAC TTC CAA TGG CGT G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77231943"/>
                  </a:ext>
                </a:extLst>
              </a:tr>
              <a:tr h="450826">
                <a:tc>
                  <a:txBody>
                    <a:bodyPr/>
                    <a:lstStyle/>
                    <a:p>
                      <a:r>
                        <a:rPr kumimoji="1" lang="en-US" altLang="ja-JP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11a1</a:t>
                      </a:r>
                      <a:endParaRPr kumimoji="1" lang="ja-JP" alt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fr-FR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 GTG GCC TAT CAC CAG TA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T GCT </a:t>
                      </a:r>
                      <a:r>
                        <a:rPr kumimoji="1" lang="en-US" altLang="ja-JP" sz="11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T</a:t>
                      </a:r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GA TGC GTC TG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46550746"/>
                  </a:ext>
                </a:extLst>
              </a:tr>
              <a:tr h="450826">
                <a:tc>
                  <a:txBody>
                    <a:bodyPr/>
                    <a:lstStyle/>
                    <a:p>
                      <a:r>
                        <a:rPr kumimoji="1" lang="en-US" altLang="ja-JP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17a1</a:t>
                      </a:r>
                      <a:endParaRPr kumimoji="1" lang="ja-JP" alt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 GAG GGT ATC GTG GAT GC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G AAC TTC TCC CTG CAC TT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0258388"/>
                  </a:ext>
                </a:extLst>
              </a:tr>
              <a:tr h="450826">
                <a:tc>
                  <a:txBody>
                    <a:bodyPr/>
                    <a:lstStyle/>
                    <a:p>
                      <a:r>
                        <a:rPr kumimoji="1" lang="en-US" altLang="ja-JP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b1</a:t>
                      </a:r>
                      <a:endParaRPr kumimoji="1" lang="ja-JP" alt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G AAT ACA GGG CTT TCG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 CGA CGT TTG GGA CTG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74015527"/>
                  </a:ext>
                </a:extLst>
              </a:tr>
              <a:tr h="450826">
                <a:tc>
                  <a:txBody>
                    <a:bodyPr/>
                    <a:lstStyle/>
                    <a:p>
                      <a:r>
                        <a:rPr kumimoji="1" lang="en-US" altLang="ja-JP" sz="11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S rRNA</a:t>
                      </a:r>
                      <a:endParaRPr kumimoji="1" lang="ja-JP" altLang="en-US" sz="11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 CGA CGT TTG GGA CTG</a:t>
                      </a:r>
                    </a:p>
                    <a:p>
                      <a:r>
                        <a:rPr kumimoji="1" lang="en-US" altLang="ja-JP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T CGG CAT CGT TTA TGG TC</a:t>
                      </a:r>
                      <a:endParaRPr kumimoji="1" lang="ja-JP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2221946"/>
                  </a:ext>
                </a:extLst>
              </a:tr>
            </a:tbl>
          </a:graphicData>
        </a:graphic>
      </p:graphicFrame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98BDD767-1560-4FBA-8654-C44FD63BF28D}"/>
              </a:ext>
            </a:extLst>
          </p:cNvPr>
          <p:cNvSpPr/>
          <p:nvPr/>
        </p:nvSpPr>
        <p:spPr>
          <a:xfrm>
            <a:off x="1347468" y="927403"/>
            <a:ext cx="416306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l Table 2</a:t>
            </a:r>
          </a:p>
          <a:p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Rat primer sequences for quantitative RT-PCR </a:t>
            </a:r>
            <a:endParaRPr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14417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</TotalTime>
  <Words>184</Words>
  <Application>Microsoft Office PowerPoint</Application>
  <PresentationFormat>画面に合わせる (4:3)</PresentationFormat>
  <Paragraphs>5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user</cp:lastModifiedBy>
  <cp:revision>21</cp:revision>
  <dcterms:created xsi:type="dcterms:W3CDTF">2025-03-22T05:59:13Z</dcterms:created>
  <dcterms:modified xsi:type="dcterms:W3CDTF">2025-12-19T02:56:23Z</dcterms:modified>
</cp:coreProperties>
</file>